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54"/>
  </p:normalViewPr>
  <p:slideViewPr>
    <p:cSldViewPr snapToGrid="0" snapToObjects="1">
      <p:cViewPr varScale="1">
        <p:scale>
          <a:sx n="197" d="100"/>
          <a:sy n="197" d="100"/>
        </p:scale>
        <p:origin x="100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82C056-98FE-3841-8778-30B9063DE8A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FE1E93-2F5E-A545-9F7D-4DF15D3D5A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628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FE1E93-2F5E-A545-9F7D-4DF15D3D5A3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677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828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893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963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850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264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542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851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546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949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513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32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3ABAA-5E61-A74F-B352-C4046C4306B4}" type="datetimeFigureOut">
              <a:rPr lang="en-US" smtClean="0"/>
              <a:t>8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0956F-E951-0D4B-A1FF-E2DE31A18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487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703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Fig 7B</a:t>
            </a:r>
          </a:p>
        </p:txBody>
      </p:sp>
      <p:grpSp>
        <p:nvGrpSpPr>
          <p:cNvPr id="210" name="Group 209"/>
          <p:cNvGrpSpPr/>
          <p:nvPr/>
        </p:nvGrpSpPr>
        <p:grpSpPr>
          <a:xfrm>
            <a:off x="127479" y="1870056"/>
            <a:ext cx="4266711" cy="1163631"/>
            <a:chOff x="127479" y="1870056"/>
            <a:chExt cx="4266711" cy="116363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7453" y="1870056"/>
              <a:ext cx="2981054" cy="11636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1220106" y="2265014"/>
              <a:ext cx="1380067" cy="2116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560790" y="2409285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60790" y="2493961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60790" y="2688693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560790" y="2879367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3602312" y="2311149"/>
              <a:ext cx="7918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FANCD2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75189" y="2252515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40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84644" y="2372488"/>
              <a:ext cx="3891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15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46510" y="254767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80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46510" y="2745213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65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27479" y="2089964"/>
              <a:ext cx="4981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(</a:t>
              </a:r>
              <a:r>
                <a:rPr lang="en-US" sz="1000" dirty="0" err="1">
                  <a:latin typeface="Helvetica"/>
                  <a:cs typeface="Helvetica"/>
                </a:rPr>
                <a:t>kDa</a:t>
              </a:r>
              <a:r>
                <a:rPr lang="en-US" sz="1000" dirty="0">
                  <a:latin typeface="Helvetica"/>
                  <a:cs typeface="Helvetica"/>
                </a:rPr>
                <a:t>)</a:t>
              </a:r>
            </a:p>
          </p:txBody>
        </p:sp>
      </p:grpSp>
      <p:grpSp>
        <p:nvGrpSpPr>
          <p:cNvPr id="211" name="Group 210"/>
          <p:cNvGrpSpPr/>
          <p:nvPr/>
        </p:nvGrpSpPr>
        <p:grpSpPr>
          <a:xfrm>
            <a:off x="1132569" y="135616"/>
            <a:ext cx="2750857" cy="1760526"/>
            <a:chOff x="1132569" y="135616"/>
            <a:chExt cx="2750857" cy="1760526"/>
          </a:xfrm>
        </p:grpSpPr>
        <p:sp>
          <p:nvSpPr>
            <p:cNvPr id="83" name="TextBox 82"/>
            <p:cNvSpPr txBox="1"/>
            <p:nvPr/>
          </p:nvSpPr>
          <p:spPr>
            <a:xfrm>
              <a:off x="1190495" y="1619143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346840" y="1619143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533016" y="1619143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689361" y="1619143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875537" y="1619143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031882" y="1619143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218058" y="1619143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374405" y="1619143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cxnSp>
          <p:nvCxnSpPr>
            <p:cNvPr id="94" name="Straight Connector 93"/>
            <p:cNvCxnSpPr/>
            <p:nvPr/>
          </p:nvCxnSpPr>
          <p:spPr>
            <a:xfrm>
              <a:off x="1262723" y="1679924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 rot="16200000">
              <a:off x="1163274" y="1386383"/>
              <a:ext cx="423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WT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 rot="16200000">
              <a:off x="969377" y="885463"/>
              <a:ext cx="1439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Helvetica"/>
                  <a:cs typeface="Helvetica"/>
                </a:rPr>
                <a:t>smc5-mAIDEGFP</a:t>
              </a: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1259279" y="389071"/>
              <a:ext cx="614378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/>
            <p:cNvSpPr txBox="1"/>
            <p:nvPr/>
          </p:nvSpPr>
          <p:spPr>
            <a:xfrm>
              <a:off x="1132569" y="135616"/>
              <a:ext cx="9204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Input 0.5%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906805" y="144081"/>
              <a:ext cx="731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IP: GFP</a:t>
              </a: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1603657" y="1679924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1944591" y="1679924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2285524" y="1679924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/>
            <p:cNvSpPr txBox="1"/>
            <p:nvPr/>
          </p:nvSpPr>
          <p:spPr>
            <a:xfrm>
              <a:off x="2544285" y="1627445"/>
              <a:ext cx="13391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/>
                  <a:cs typeface="Helvetica"/>
                </a:rPr>
                <a:t>Cisplatin</a:t>
              </a:r>
              <a:r>
                <a:rPr lang="en-US" sz="1000" dirty="0">
                  <a:latin typeface="Helvetica"/>
                  <a:cs typeface="Helvetica"/>
                </a:rPr>
                <a:t> (1 </a:t>
              </a:r>
              <a:r>
                <a:rPr lang="en-US" sz="1000" dirty="0" err="1">
                  <a:latin typeface="Helvetica"/>
                  <a:cs typeface="Helvetica"/>
                </a:rPr>
                <a:t>μM</a:t>
              </a:r>
              <a:r>
                <a:rPr lang="en-US" sz="1000" dirty="0">
                  <a:latin typeface="Helvetica"/>
                  <a:cs typeface="Helvetica"/>
                </a:rPr>
                <a:t>, 3 h)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1661353" y="876998"/>
              <a:ext cx="1439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Helvetica"/>
                  <a:cs typeface="Helvetica"/>
                </a:rPr>
                <a:t>smc5-mAIDEGFP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1857384" y="1386384"/>
              <a:ext cx="423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WT</a:t>
              </a:r>
            </a:p>
          </p:txBody>
        </p:sp>
        <p:cxnSp>
          <p:nvCxnSpPr>
            <p:cNvPr id="117" name="Straight Connector 116"/>
            <p:cNvCxnSpPr/>
            <p:nvPr/>
          </p:nvCxnSpPr>
          <p:spPr>
            <a:xfrm>
              <a:off x="1950971" y="389071"/>
              <a:ext cx="614378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0" name="TextBox 139"/>
          <p:cNvSpPr txBox="1"/>
          <p:nvPr/>
        </p:nvSpPr>
        <p:spPr>
          <a:xfrm>
            <a:off x="1259279" y="3292622"/>
            <a:ext cx="374440" cy="2116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41" name="TextBox 140"/>
          <p:cNvSpPr txBox="1"/>
          <p:nvPr/>
        </p:nvSpPr>
        <p:spPr>
          <a:xfrm>
            <a:off x="1626998" y="3261369"/>
            <a:ext cx="1258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= Cropped area</a:t>
            </a:r>
          </a:p>
        </p:txBody>
      </p:sp>
      <p:grpSp>
        <p:nvGrpSpPr>
          <p:cNvPr id="208" name="Group 207"/>
          <p:cNvGrpSpPr/>
          <p:nvPr/>
        </p:nvGrpSpPr>
        <p:grpSpPr>
          <a:xfrm>
            <a:off x="4537414" y="1715021"/>
            <a:ext cx="4215314" cy="2418536"/>
            <a:chOff x="4537414" y="1715021"/>
            <a:chExt cx="4215314" cy="2418536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32180" y="1715021"/>
              <a:ext cx="3060000" cy="2418536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5625635" y="2110825"/>
              <a:ext cx="1380067" cy="2116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4924180" y="2284461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4924180" y="2369137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924180" y="2563869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4924180" y="2754543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4924180" y="2978728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924180" y="3656070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924180" y="3258136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4924180" y="3448810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4924180" y="3876203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4924180" y="3960869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8038019" y="2645901"/>
              <a:ext cx="714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Helvetica"/>
                  <a:cs typeface="Helvetica"/>
                </a:rPr>
                <a:t>GFP</a:t>
              </a:r>
            </a:p>
            <a:p>
              <a:pPr algn="ctr"/>
              <a:r>
                <a:rPr lang="en-US" sz="1200" dirty="0">
                  <a:latin typeface="Helvetica"/>
                  <a:cs typeface="Helvetica"/>
                </a:rPr>
                <a:t>(SMC5)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591957" y="2133959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40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01412" y="2253932"/>
              <a:ext cx="3891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15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663278" y="2429120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80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663278" y="2637437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65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663278" y="3120329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63278" y="2845754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50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663278" y="3317603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663278" y="3514877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25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663278" y="3843167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663278" y="3723194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5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537414" y="2014748"/>
              <a:ext cx="4981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(</a:t>
              </a:r>
              <a:r>
                <a:rPr lang="en-US" sz="1000" dirty="0" err="1">
                  <a:latin typeface="Helvetica"/>
                  <a:cs typeface="Helvetica"/>
                </a:rPr>
                <a:t>kDa</a:t>
              </a:r>
              <a:r>
                <a:rPr lang="en-US" sz="1000" dirty="0">
                  <a:latin typeface="Helvetica"/>
                  <a:cs typeface="Helvetica"/>
                </a:rPr>
                <a:t>)</a:t>
              </a:r>
            </a:p>
          </p:txBody>
        </p:sp>
      </p:grpSp>
      <p:grpSp>
        <p:nvGrpSpPr>
          <p:cNvPr id="209" name="Group 208"/>
          <p:cNvGrpSpPr/>
          <p:nvPr/>
        </p:nvGrpSpPr>
        <p:grpSpPr>
          <a:xfrm>
            <a:off x="4545945" y="4195450"/>
            <a:ext cx="4117942" cy="2423410"/>
            <a:chOff x="4545945" y="4195450"/>
            <a:chExt cx="4117942" cy="2423410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32180" y="4195450"/>
              <a:ext cx="3060000" cy="2418536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4" name="TextBox 13"/>
            <p:cNvSpPr txBox="1"/>
            <p:nvPr/>
          </p:nvSpPr>
          <p:spPr>
            <a:xfrm>
              <a:off x="5625635" y="4718625"/>
              <a:ext cx="1380067" cy="21166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4924180" y="4805490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4924180" y="4907100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4924180" y="5101832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4924180" y="5292506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4924180" y="5516691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4924180" y="6194033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4924180" y="5796099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4924180" y="5986773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4924180" y="6414166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4924180" y="6498832"/>
              <a:ext cx="108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8043204" y="5228454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SMC6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591957" y="4663431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40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601412" y="4783404"/>
              <a:ext cx="3891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15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663278" y="495859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80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663278" y="5166909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65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663278" y="5649801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4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663278" y="537522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50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663278" y="5847075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30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663278" y="6044349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25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663278" y="6372639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0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663278" y="6252666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15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545945" y="4550562"/>
              <a:ext cx="4981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Helvetica"/>
                  <a:cs typeface="Helvetica"/>
                </a:rPr>
                <a:t>(</a:t>
              </a:r>
              <a:r>
                <a:rPr lang="en-US" sz="1000" dirty="0" err="1">
                  <a:latin typeface="Helvetica"/>
                  <a:cs typeface="Helvetica"/>
                </a:rPr>
                <a:t>kDa</a:t>
              </a:r>
              <a:r>
                <a:rPr lang="en-US" sz="1000" dirty="0">
                  <a:latin typeface="Helvetica"/>
                  <a:cs typeface="Helvetica"/>
                </a:rPr>
                <a:t>)</a:t>
              </a:r>
            </a:p>
          </p:txBody>
        </p:sp>
      </p:grpSp>
      <p:grpSp>
        <p:nvGrpSpPr>
          <p:cNvPr id="207" name="Group 206"/>
          <p:cNvGrpSpPr/>
          <p:nvPr/>
        </p:nvGrpSpPr>
        <p:grpSpPr>
          <a:xfrm>
            <a:off x="5554864" y="-24412"/>
            <a:ext cx="2750857" cy="1760526"/>
            <a:chOff x="5521147" y="-58126"/>
            <a:chExt cx="2750857" cy="1760526"/>
          </a:xfrm>
        </p:grpSpPr>
        <p:sp>
          <p:nvSpPr>
            <p:cNvPr id="186" name="TextBox 185"/>
            <p:cNvSpPr txBox="1"/>
            <p:nvPr/>
          </p:nvSpPr>
          <p:spPr>
            <a:xfrm>
              <a:off x="5579073" y="1425401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5735418" y="1425401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5921594" y="1425401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6077939" y="1425401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6264115" y="1425401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6420460" y="1425401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6606636" y="1425401"/>
              <a:ext cx="235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-</a:t>
              </a: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6762983" y="1425401"/>
              <a:ext cx="274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+</a:t>
              </a:r>
            </a:p>
          </p:txBody>
        </p:sp>
        <p:cxnSp>
          <p:nvCxnSpPr>
            <p:cNvPr id="194" name="Straight Connector 193"/>
            <p:cNvCxnSpPr/>
            <p:nvPr/>
          </p:nvCxnSpPr>
          <p:spPr>
            <a:xfrm>
              <a:off x="5651301" y="1486182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/>
            <p:cNvSpPr txBox="1"/>
            <p:nvPr/>
          </p:nvSpPr>
          <p:spPr>
            <a:xfrm rot="16200000">
              <a:off x="5551852" y="1192641"/>
              <a:ext cx="423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WT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 rot="16200000">
              <a:off x="5357955" y="691721"/>
              <a:ext cx="1439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Helvetica"/>
                  <a:cs typeface="Helvetica"/>
                </a:rPr>
                <a:t>smc5-mAIDEGFP</a:t>
              </a:r>
            </a:p>
          </p:txBody>
        </p:sp>
        <p:cxnSp>
          <p:nvCxnSpPr>
            <p:cNvPr id="197" name="Straight Connector 196"/>
            <p:cNvCxnSpPr/>
            <p:nvPr/>
          </p:nvCxnSpPr>
          <p:spPr>
            <a:xfrm>
              <a:off x="5647857" y="195329"/>
              <a:ext cx="614378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/>
            <p:cNvSpPr txBox="1"/>
            <p:nvPr/>
          </p:nvSpPr>
          <p:spPr>
            <a:xfrm>
              <a:off x="5521147" y="-58126"/>
              <a:ext cx="9204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Input 0.5%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6295383" y="-49661"/>
              <a:ext cx="731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IP: GFP</a:t>
              </a:r>
            </a:p>
          </p:txBody>
        </p:sp>
        <p:cxnSp>
          <p:nvCxnSpPr>
            <p:cNvPr id="200" name="Straight Connector 199"/>
            <p:cNvCxnSpPr/>
            <p:nvPr/>
          </p:nvCxnSpPr>
          <p:spPr>
            <a:xfrm>
              <a:off x="5992235" y="1486182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/>
            <p:cNvCxnSpPr/>
            <p:nvPr/>
          </p:nvCxnSpPr>
          <p:spPr>
            <a:xfrm>
              <a:off x="6333169" y="1486182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201"/>
            <p:cNvCxnSpPr/>
            <p:nvPr/>
          </p:nvCxnSpPr>
          <p:spPr>
            <a:xfrm>
              <a:off x="6674102" y="1486182"/>
              <a:ext cx="270000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TextBox 202"/>
            <p:cNvSpPr txBox="1"/>
            <p:nvPr/>
          </p:nvSpPr>
          <p:spPr>
            <a:xfrm>
              <a:off x="6932863" y="1433703"/>
              <a:ext cx="13391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Helvetica"/>
                  <a:cs typeface="Helvetica"/>
                </a:rPr>
                <a:t>Cisplatin</a:t>
              </a:r>
              <a:r>
                <a:rPr lang="en-US" sz="1000" dirty="0">
                  <a:latin typeface="Helvetica"/>
                  <a:cs typeface="Helvetica"/>
                </a:rPr>
                <a:t> (1 </a:t>
              </a:r>
              <a:r>
                <a:rPr lang="en-US" sz="1000" dirty="0" err="1">
                  <a:latin typeface="Helvetica"/>
                  <a:cs typeface="Helvetica"/>
                </a:rPr>
                <a:t>μM</a:t>
              </a:r>
              <a:r>
                <a:rPr lang="en-US" sz="1000" dirty="0">
                  <a:latin typeface="Helvetica"/>
                  <a:cs typeface="Helvetica"/>
                </a:rPr>
                <a:t>, 3 h)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 rot="16200000">
              <a:off x="6049931" y="683256"/>
              <a:ext cx="14399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Helvetica"/>
                  <a:cs typeface="Helvetica"/>
                </a:rPr>
                <a:t>smc5-mAIDEGFP</a:t>
              </a:r>
            </a:p>
          </p:txBody>
        </p:sp>
        <p:sp>
          <p:nvSpPr>
            <p:cNvPr id="205" name="TextBox 204"/>
            <p:cNvSpPr txBox="1"/>
            <p:nvPr/>
          </p:nvSpPr>
          <p:spPr>
            <a:xfrm rot="16200000">
              <a:off x="6245962" y="1192642"/>
              <a:ext cx="423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WT</a:t>
              </a:r>
            </a:p>
          </p:txBody>
        </p:sp>
        <p:cxnSp>
          <p:nvCxnSpPr>
            <p:cNvPr id="206" name="Straight Connector 205"/>
            <p:cNvCxnSpPr/>
            <p:nvPr/>
          </p:nvCxnSpPr>
          <p:spPr>
            <a:xfrm>
              <a:off x="6339549" y="195329"/>
              <a:ext cx="614378" cy="0"/>
            </a:xfrm>
            <a:prstGeom prst="line">
              <a:avLst/>
            </a:prstGeom>
            <a:ln w="1270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6115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200" dirty="0" smtClean="0">
            <a:latin typeface="Helvetica"/>
            <a:cs typeface="Helvetica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97</Words>
  <Application>Microsoft Macintosh PowerPoint</Application>
  <PresentationFormat>On-screen Show (4:3)</PresentationFormat>
  <Paragraphs>6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mp dept</dc:creator>
  <cp:lastModifiedBy>Dana Branzei</cp:lastModifiedBy>
  <cp:revision>8</cp:revision>
  <dcterms:created xsi:type="dcterms:W3CDTF">2019-08-15T16:51:37Z</dcterms:created>
  <dcterms:modified xsi:type="dcterms:W3CDTF">2019-08-16T09:04:06Z</dcterms:modified>
</cp:coreProperties>
</file>